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75D11-CC61-4C70-9789-826668D933C0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14B02-185B-4633-97B1-1AD2070E95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127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75D11-CC61-4C70-9789-826668D933C0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14B02-185B-4633-97B1-1AD2070E95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00621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75D11-CC61-4C70-9789-826668D933C0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14B02-185B-4633-97B1-1AD2070E95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2790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75D11-CC61-4C70-9789-826668D933C0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14B02-185B-4633-97B1-1AD2070E95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0670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75D11-CC61-4C70-9789-826668D933C0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14B02-185B-4633-97B1-1AD2070E95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6712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75D11-CC61-4C70-9789-826668D933C0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14B02-185B-4633-97B1-1AD2070E95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7942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75D11-CC61-4C70-9789-826668D933C0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14B02-185B-4633-97B1-1AD2070E95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13536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75D11-CC61-4C70-9789-826668D933C0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14B02-185B-4633-97B1-1AD2070E95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071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75D11-CC61-4C70-9789-826668D933C0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14B02-185B-4633-97B1-1AD2070E95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664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75D11-CC61-4C70-9789-826668D933C0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14B02-185B-4633-97B1-1AD2070E95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4427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75D11-CC61-4C70-9789-826668D933C0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14B02-185B-4633-97B1-1AD2070E95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0225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475D11-CC61-4C70-9789-826668D933C0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E14B02-185B-4633-97B1-1AD2070E95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266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4752" y="358008"/>
            <a:ext cx="4035550" cy="5247810"/>
          </a:xfrm>
          <a:prstGeom prst="rect">
            <a:avLst/>
          </a:prstGeom>
        </p:spPr>
      </p:pic>
      <p:sp>
        <p:nvSpPr>
          <p:cNvPr id="5" name="Text Box 2"/>
          <p:cNvSpPr txBox="1">
            <a:spLocks noChangeArrowheads="1"/>
          </p:cNvSpPr>
          <p:nvPr/>
        </p:nvSpPr>
        <p:spPr bwMode="auto">
          <a:xfrm>
            <a:off x="2296634" y="5660550"/>
            <a:ext cx="8410352" cy="963908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2. Immune staining of isolated ileum Peyer’s patch cells and macrophage function.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Antibodies against CD (Cluster differentiation) markers: CD3 (T lymphocytes), CD4 (T helper cells), CD8 (cytotoxic T cells), CD21 (B cells), CD14 (monocytes), CD203a (macrophages), CD25 (activation antigen for mononuclear cells), </a:t>
            </a:r>
            <a:r>
              <a:rPr kumimoji="0" lang="en-US" altLang="en-US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LADq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(antigen presentation/activation) (A). Phagocytic activity of isolated macrophages at 30 min intervals in vitro (B). Bar represents means</a:t>
            </a:r>
            <a:r>
              <a:rPr kumimoji="0" lang="en-US" altLang="en-US" sz="1200" b="0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± SD for each of the measurements for cells from control (blue), 3-servings (red) or 6-servings fed group (B).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30" t="16021" b="23400"/>
          <a:stretch/>
        </p:blipFill>
        <p:spPr>
          <a:xfrm>
            <a:off x="7381324" y="1297173"/>
            <a:ext cx="3155541" cy="2320858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679944" y="58479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6932428" y="76945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035075" y="1833859"/>
            <a:ext cx="346249" cy="80086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050" dirty="0"/>
              <a:t>Phagocytosis</a:t>
            </a:r>
          </a:p>
        </p:txBody>
      </p:sp>
    </p:spTree>
    <p:extLst>
      <p:ext uri="{BB962C8B-B14F-4D97-AF65-F5344CB8AC3E}">
        <p14:creationId xmlns:p14="http://schemas.microsoft.com/office/powerpoint/2010/main" val="26145108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9</TotalTime>
  <Words>115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lano-Aguilar, Gloria</dc:creator>
  <cp:lastModifiedBy>Solano-Aguilar, Gloria</cp:lastModifiedBy>
  <cp:revision>9</cp:revision>
  <dcterms:created xsi:type="dcterms:W3CDTF">2018-09-19T14:29:31Z</dcterms:created>
  <dcterms:modified xsi:type="dcterms:W3CDTF">2018-11-07T23:16:15Z</dcterms:modified>
</cp:coreProperties>
</file>